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185235-6F12-A6C1-1BFA-4B926303E7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B98BB03-D1BC-A64B-AB12-A31BA1EBA4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B6ACD5-D9F5-1798-198E-A61ED8E14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43A8CB-5A93-863F-44BF-06A1862C0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959D29-1657-40DF-949F-5B9BE04DB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4639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33075A-6FF0-2FA6-E2A3-DFB9E2C00C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C655F3-C249-60D5-F133-49998C05F6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7FB1D6-146B-7229-1ADE-7277086D6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8DE456-5623-4892-E516-E4AEBFB79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5F5A94-CD56-BEDA-AFBF-F0933C1C9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453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3F78F6-E3B2-00EF-1C13-2DFC5BB94A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168FF5A-FB12-7046-CA77-BF863FFC24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09F5E4-B990-7DEA-C0EC-CDFD7264B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087671-FD9F-D861-0B05-F39E96167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87B722-A720-45B3-CDBF-335AD2D0C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3723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DEBA83-36B2-6E76-CCFF-FFCE6145F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0504881-0181-EE6B-C5AD-CEB5C67730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F79189-E25C-DF8E-8FFA-D007ACFF5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F919A0-F407-84BE-3596-0919D0E1F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6001C9-7742-B18F-E69D-CB25EE9B3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8606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2F160D-B167-3C10-228E-D5C8ED0D2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86D8C9-C252-279F-B966-53D6D8B7A6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0B145B-A605-CA48-4AC7-056480DE8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1AE99B-7C49-0F60-B5D9-4245AB727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BC86BF-01F3-824F-2197-F060DAC80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5252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A0EC77-95B3-C3BC-C5C6-F21F4475D3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E2662EA-CFAB-DC00-60CD-AE2A4F3D2D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50C27C-D747-D2CC-82D9-1089942CF9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259FE0-AE4C-B811-28E4-B25DCC6B6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8123612-8DA1-39E5-DDD6-FDF55BDAC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07DAD4D-185B-8596-5BFE-DFC32D85E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9476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8A334F-664F-836F-AF09-538164341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0893F6D-E7EC-8187-D97D-94BAEED600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5B63187-2488-0AE2-A55C-4F4C4D9DFA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0A47A1A-0CDF-FEC7-06BB-B5CB625C79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E68733-0BBB-9678-544D-3D27B2FFA5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B6F4606-26E1-E06D-8C18-7E6178E60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99C7B14-F11D-F5BB-2960-10D8DD5A1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88BAADD-2F01-D432-4D1A-CA90179DE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88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924146-2470-6C27-69FA-DF2858B7B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32F04DD-7920-C595-0D97-D28430C6D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7E56262-9B64-2C30-AA99-66D430ECA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FF12648-F98C-6B93-1F20-428A13133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696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4D5EBAB-20A6-26EF-8B18-CC1E1627D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9A3AF33-360E-8BDD-6112-9C791ED9A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CEBDB5E-94CE-5390-48AC-9ECFAE6C3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835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EA5B06-6660-312B-DC86-B988FD553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EEF01B-23BD-A2D7-BB95-8FCCA11E64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E48227-E7B0-3476-4621-290E2033B8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7EF50D-3124-3D2F-25B1-0AEECD61A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6E145E-BF44-F1F8-3FA3-83C9A8470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6F234E-C62F-47F3-2E2C-6BB2AE37F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1857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C1348D-6043-B2E9-772F-DB888CD54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7E1E641-1AF4-C358-11C4-985115C9A8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B24055-8A29-09D0-2FA8-5377E0A1D8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1D79CA-FEBF-0CCC-A20A-CC2E5F12E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144349-4999-FC0B-3B04-36F218E1E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C7ADBE-C223-3C82-7613-D3D083C3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68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70F5E88-B2C8-E71C-8CF0-131E6997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BE1174-1E5C-72D9-7872-EBF41BDB9F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F872A7-52FC-071F-4748-2D16C7E491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92099-D86C-4ABE-9B16-065536CC6EB8}" type="datetimeFigureOut">
              <a:rPr lang="zh-CN" altLang="en-US" smtClean="0"/>
              <a:t>2026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9CF59F-AA76-EF5F-7CE9-ECD90098E3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1FEC8A-A831-25C6-B2A7-363B591005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6DA86-6B49-44F3-9828-B4C158B7C4D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381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>
            <a:extLst>
              <a:ext uri="{FF2B5EF4-FFF2-40B4-BE49-F238E27FC236}">
                <a16:creationId xmlns:a16="http://schemas.microsoft.com/office/drawing/2014/main" id="{3DBC2789-08C0-AEC5-DE24-C2666EC4926B}"/>
              </a:ext>
            </a:extLst>
          </p:cNvPr>
          <p:cNvGrpSpPr/>
          <p:nvPr/>
        </p:nvGrpSpPr>
        <p:grpSpPr>
          <a:xfrm>
            <a:off x="3094286" y="1151592"/>
            <a:ext cx="5962650" cy="4772025"/>
            <a:chOff x="3094286" y="1151592"/>
            <a:chExt cx="5962650" cy="477202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4788711-9506-8C1D-DEFF-B69607BFA8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94286" y="1151592"/>
              <a:ext cx="5962650" cy="4772025"/>
            </a:xfrm>
            <a:prstGeom prst="rect">
              <a:avLst/>
            </a:prstGeom>
          </p:spPr>
        </p:pic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7A3E33FB-A7F7-2E7E-C790-88E041A201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24960" y="1361440"/>
              <a:ext cx="0" cy="16154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790942E0-8E28-56E7-E4D7-5E571969948B}"/>
                </a:ext>
              </a:extLst>
            </p:cNvPr>
            <p:cNvCxnSpPr/>
            <p:nvPr/>
          </p:nvCxnSpPr>
          <p:spPr>
            <a:xfrm>
              <a:off x="4135120" y="1351280"/>
              <a:ext cx="45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6D292258-F967-CA83-7F2D-A2C6D2040B2E}"/>
                </a:ext>
              </a:extLst>
            </p:cNvPr>
            <p:cNvCxnSpPr/>
            <p:nvPr/>
          </p:nvCxnSpPr>
          <p:spPr>
            <a:xfrm>
              <a:off x="8707120" y="1361440"/>
              <a:ext cx="0" cy="1320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C9FCD7F8-79D2-0447-4618-7773E73151A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46880" y="1666240"/>
              <a:ext cx="0" cy="13004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A04F0761-410A-9821-77E3-98611FB967AA}"/>
                </a:ext>
              </a:extLst>
            </p:cNvPr>
            <p:cNvCxnSpPr/>
            <p:nvPr/>
          </p:nvCxnSpPr>
          <p:spPr>
            <a:xfrm>
              <a:off x="4257040" y="1645920"/>
              <a:ext cx="21336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EF877850-21A0-CE5D-8D7F-561A9E5B2B2A}"/>
                </a:ext>
              </a:extLst>
            </p:cNvPr>
            <p:cNvCxnSpPr/>
            <p:nvPr/>
          </p:nvCxnSpPr>
          <p:spPr>
            <a:xfrm>
              <a:off x="6400800" y="1676400"/>
              <a:ext cx="0" cy="4775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8CEBE3F1-55B7-239D-BC4A-F2DD5A37B28A}"/>
                </a:ext>
              </a:extLst>
            </p:cNvPr>
            <p:cNvCxnSpPr/>
            <p:nvPr/>
          </p:nvCxnSpPr>
          <p:spPr>
            <a:xfrm>
              <a:off x="6421120" y="4145280"/>
              <a:ext cx="228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613CF802-77C1-F449-A5B5-B2A245642678}"/>
                </a:ext>
              </a:extLst>
            </p:cNvPr>
            <p:cNvCxnSpPr/>
            <p:nvPr/>
          </p:nvCxnSpPr>
          <p:spPr>
            <a:xfrm flipH="1" flipV="1">
              <a:off x="6410960" y="3891280"/>
              <a:ext cx="10160" cy="2438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4E89B85C-083C-AF42-575E-1555ED3D294D}"/>
                </a:ext>
              </a:extLst>
            </p:cNvPr>
            <p:cNvCxnSpPr/>
            <p:nvPr/>
          </p:nvCxnSpPr>
          <p:spPr>
            <a:xfrm flipH="1" flipV="1">
              <a:off x="8707120" y="3891280"/>
              <a:ext cx="10160" cy="24384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7E37F086-5DC3-68DD-7AB3-97D858B58E41}"/>
                </a:ext>
              </a:extLst>
            </p:cNvPr>
            <p:cNvSpPr txBox="1"/>
            <p:nvPr/>
          </p:nvSpPr>
          <p:spPr>
            <a:xfrm>
              <a:off x="5770880" y="115571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/>
                <a:t>P&lt;0.05</a:t>
              </a:r>
              <a:endParaRPr lang="zh-CN" altLang="en-US" sz="11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019F3302-5969-A7C0-3414-66F17C8B10EE}"/>
                </a:ext>
              </a:extLst>
            </p:cNvPr>
            <p:cNvSpPr txBox="1"/>
            <p:nvPr/>
          </p:nvSpPr>
          <p:spPr>
            <a:xfrm>
              <a:off x="4856480" y="139955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/>
                <a:t>P&lt;0.05</a:t>
              </a:r>
              <a:endParaRPr lang="zh-CN" altLang="en-US" sz="11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8987D66B-E769-23B5-DC36-90C34D2774CD}"/>
                </a:ext>
              </a:extLst>
            </p:cNvPr>
            <p:cNvSpPr txBox="1"/>
            <p:nvPr/>
          </p:nvSpPr>
          <p:spPr>
            <a:xfrm>
              <a:off x="7396480" y="413259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/>
                <a:t>P&lt;0.05</a:t>
              </a:r>
              <a:endParaRPr lang="zh-CN" altLang="en-US" sz="1100" dirty="0"/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1D869E41-B7CE-B46B-7045-5CDB38590731}"/>
              </a:ext>
            </a:extLst>
          </p:cNvPr>
          <p:cNvSpPr txBox="1"/>
          <p:nvPr/>
        </p:nvSpPr>
        <p:spPr>
          <a:xfrm>
            <a:off x="3210560" y="581029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1. The dot plots of uric levels in UAR group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782758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>
            <a:extLst>
              <a:ext uri="{FF2B5EF4-FFF2-40B4-BE49-F238E27FC236}">
                <a16:creationId xmlns:a16="http://schemas.microsoft.com/office/drawing/2014/main" id="{CEE894B8-DA09-7742-2B1E-26DAD3FAEA25}"/>
              </a:ext>
            </a:extLst>
          </p:cNvPr>
          <p:cNvGrpSpPr/>
          <p:nvPr/>
        </p:nvGrpSpPr>
        <p:grpSpPr>
          <a:xfrm>
            <a:off x="3114675" y="1042987"/>
            <a:ext cx="5962650" cy="4772025"/>
            <a:chOff x="3114675" y="1042987"/>
            <a:chExt cx="5962650" cy="477202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7F9448D-26BB-84F5-B7B3-6E0F56F288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4675" y="1042987"/>
              <a:ext cx="5962650" cy="4772025"/>
            </a:xfrm>
            <a:prstGeom prst="rect">
              <a:avLst/>
            </a:prstGeom>
          </p:spPr>
        </p:pic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E1F20760-764E-95AC-16F4-DB72F5CC9A89}"/>
                </a:ext>
              </a:extLst>
            </p:cNvPr>
            <p:cNvCxnSpPr/>
            <p:nvPr/>
          </p:nvCxnSpPr>
          <p:spPr>
            <a:xfrm>
              <a:off x="4094480" y="3352800"/>
              <a:ext cx="0" cy="2743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D1E9A87-5C15-C24B-B792-F8CFBD91C4E5}"/>
                </a:ext>
              </a:extLst>
            </p:cNvPr>
            <p:cNvCxnSpPr/>
            <p:nvPr/>
          </p:nvCxnSpPr>
          <p:spPr>
            <a:xfrm>
              <a:off x="4094480" y="3616960"/>
              <a:ext cx="22453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F231DA76-020E-1A5A-D7BA-494F82E5A1AD}"/>
                </a:ext>
              </a:extLst>
            </p:cNvPr>
            <p:cNvCxnSpPr/>
            <p:nvPr/>
          </p:nvCxnSpPr>
          <p:spPr>
            <a:xfrm>
              <a:off x="6350000" y="3352800"/>
              <a:ext cx="0" cy="2743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66AE05E6-0E95-300B-0408-F3EB5D36CF5C}"/>
                </a:ext>
              </a:extLst>
            </p:cNvPr>
            <p:cNvCxnSpPr>
              <a:cxnSpLocks/>
            </p:cNvCxnSpPr>
            <p:nvPr/>
          </p:nvCxnSpPr>
          <p:spPr>
            <a:xfrm>
              <a:off x="3921760" y="3469640"/>
              <a:ext cx="0" cy="150876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C454596A-53A6-C76E-419B-C514C6EDD40E}"/>
                </a:ext>
              </a:extLst>
            </p:cNvPr>
            <p:cNvCxnSpPr>
              <a:cxnSpLocks/>
            </p:cNvCxnSpPr>
            <p:nvPr/>
          </p:nvCxnSpPr>
          <p:spPr>
            <a:xfrm>
              <a:off x="3911600" y="4978400"/>
              <a:ext cx="48971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29EFA8FB-6EB6-9F03-7B85-D260C3A84C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08720" y="4521200"/>
              <a:ext cx="0" cy="4572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7E73F472-BA6B-AA04-7C96-0128C96504A6}"/>
                </a:ext>
              </a:extLst>
            </p:cNvPr>
            <p:cNvCxnSpPr>
              <a:cxnSpLocks/>
            </p:cNvCxnSpPr>
            <p:nvPr/>
          </p:nvCxnSpPr>
          <p:spPr>
            <a:xfrm>
              <a:off x="6492240" y="3352800"/>
              <a:ext cx="0" cy="1168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5697861D-55ED-2A22-A68C-FA5996E5940C}"/>
                </a:ext>
              </a:extLst>
            </p:cNvPr>
            <p:cNvCxnSpPr/>
            <p:nvPr/>
          </p:nvCxnSpPr>
          <p:spPr>
            <a:xfrm>
              <a:off x="6492240" y="4521200"/>
              <a:ext cx="21437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1C36836A-74F1-9AD3-14FA-0372CEB913AA}"/>
                </a:ext>
              </a:extLst>
            </p:cNvPr>
            <p:cNvCxnSpPr/>
            <p:nvPr/>
          </p:nvCxnSpPr>
          <p:spPr>
            <a:xfrm flipV="1">
              <a:off x="8636000" y="4224020"/>
              <a:ext cx="0" cy="2971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424081D-C3C2-364C-ECD5-E5C23BF98B26}"/>
                </a:ext>
              </a:extLst>
            </p:cNvPr>
            <p:cNvSpPr txBox="1"/>
            <p:nvPr/>
          </p:nvSpPr>
          <p:spPr>
            <a:xfrm>
              <a:off x="4728846" y="3660001"/>
              <a:ext cx="6511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P&gt;0.05</a:t>
              </a:r>
              <a:endParaRPr lang="zh-CN" altLang="en-US" sz="12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60FB8966-CBC3-F832-38FB-A970A6AFC252}"/>
                </a:ext>
              </a:extLst>
            </p:cNvPr>
            <p:cNvSpPr txBox="1"/>
            <p:nvPr/>
          </p:nvSpPr>
          <p:spPr>
            <a:xfrm>
              <a:off x="6014270" y="4953407"/>
              <a:ext cx="6511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P&lt;0.05</a:t>
              </a:r>
              <a:endParaRPr lang="zh-CN" altLang="en-US" sz="1200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52A5EE2-E354-18E9-C0B8-779A2247554D}"/>
                </a:ext>
              </a:extLst>
            </p:cNvPr>
            <p:cNvSpPr txBox="1"/>
            <p:nvPr/>
          </p:nvSpPr>
          <p:spPr>
            <a:xfrm>
              <a:off x="7390950" y="4676408"/>
              <a:ext cx="6511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P&lt;0.05</a:t>
              </a:r>
              <a:endParaRPr lang="zh-CN" altLang="en-US" sz="1200" dirty="0"/>
            </a:p>
          </p:txBody>
        </p: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A974C4D5-01AE-EAF7-EFDA-A7296D1C3F31}"/>
              </a:ext>
            </a:extLst>
          </p:cNvPr>
          <p:cNvSpPr txBox="1"/>
          <p:nvPr/>
        </p:nvSpPr>
        <p:spPr>
          <a:xfrm>
            <a:off x="3210560" y="581029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2. The dot plots of albumin levels in UAR group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64172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4</TotalTime>
  <Words>44</Words>
  <Application>Microsoft Office PowerPoint</Application>
  <PresentationFormat>宽屏</PresentationFormat>
  <Paragraphs>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ngkang sun</dc:creator>
  <cp:lastModifiedBy>rongkang sun</cp:lastModifiedBy>
  <cp:revision>1</cp:revision>
  <dcterms:created xsi:type="dcterms:W3CDTF">2026-05-22T05:34:07Z</dcterms:created>
  <dcterms:modified xsi:type="dcterms:W3CDTF">2026-05-24T14:58:32Z</dcterms:modified>
</cp:coreProperties>
</file>